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78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E1B7667-4541-4B4E-91C4-5AEDD44469B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ADD7B56-AE18-4A66-802E-107100AF313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315D864-D0C8-43D2-A69C-CF8DD6E1E5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C3D853-B686-49C3-9472-0C6A3D686B4B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1014AA5-64CA-43A9-89FE-4A35ACFFA2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CF8154F-61BA-4236-AD6F-B83486B4FA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1C481-E529-4F83-B096-20E2BB63B1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40289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380DCC8-31BC-4560-92FF-6A252FFD78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E23CF71-DB4C-4C25-B267-3CD09C7CF1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2D406DF-B65A-4CFE-A23D-999ED96F0B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C3D853-B686-49C3-9472-0C6A3D686B4B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F54F79F-77BF-4F28-AF00-3B051BC417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446525B-5B8B-4420-B2D3-D4A25AAFC2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1C481-E529-4F83-B096-20E2BB63B1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1766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D757FF7D-6DF7-466B-832A-F66A690657F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9782F5D-B13F-486C-92C6-D3E942FAA4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2CB0D20-609D-44D7-BBF2-0CCFA43999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C3D853-B686-49C3-9472-0C6A3D686B4B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D0047F4-40A9-45C7-92B7-B8E8761B2C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6728FF3-E96C-4B1D-9FD2-37E578A621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1C481-E529-4F83-B096-20E2BB63B1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3793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F6977E7-BB67-4815-8FC7-A6F8C21783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26163EE-178F-4B36-BFA8-5D38F4004F1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B91B36A-EE12-481E-8278-07154DDA00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C3D853-B686-49C3-9472-0C6A3D686B4B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6FBBE1F-F8EC-4C7C-8978-1D0A16021F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EC65785-F1E0-498A-8AD0-C6B62EB7C7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1C481-E529-4F83-B096-20E2BB63B1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71026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943E2C9-0721-4E8C-B319-7CE6BD09F5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0A25CFB-2A6E-4B1E-83DA-B5FF8EBFA7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3B2BD6F-5640-4EB9-88FE-5579EAA206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C3D853-B686-49C3-9472-0C6A3D686B4B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02D79D8-D14C-4829-A9E5-0F854C20B2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09B63B7-4118-4FED-8B18-CE49E2FF7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1C481-E529-4F83-B096-20E2BB63B1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49267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A3A2A4A-A788-432C-8788-6DBFCA245C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474E861-8B24-4B66-B34C-4D9816F6A64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87C7471-6DBF-44C3-B6AD-807C229E90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16170BC-7DEF-4E8E-89A9-BE6643CE05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C3D853-B686-49C3-9472-0C6A3D686B4B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1625ED8-749C-4418-92E2-09DF14AAE6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46AB017-061B-4C7C-A360-F97D20FC92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1C481-E529-4F83-B096-20E2BB63B1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22408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A5932A9-944C-421F-AD12-B4EF5C96FD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132F642-462D-4694-BC9C-AAD68EC58E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B8DB8AB-7D22-4DC5-AC0B-5C7F232C57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7D5BCB6-126F-404E-9B4D-87538413FD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9665E5E-8A66-44E3-AC06-6E773347B3F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2764A22-9321-47C1-8BD6-363D6CE443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C3D853-B686-49C3-9472-0C6A3D686B4B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04976BB-C9DE-4D4F-AE3E-BF9DD330D6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5A77DFB1-0CBD-4AB5-971F-7AE6C436B0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1C481-E529-4F83-B096-20E2BB63B1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94397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4005421-DF60-43D7-96AA-93E42818B7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A5D144B-78E7-4E29-8713-8FD70BC4A1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C3D853-B686-49C3-9472-0C6A3D686B4B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2B1EB3D-2B26-42FB-8BE1-E4F5104585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D3A9681-6835-4297-A823-93752597B7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1C481-E529-4F83-B096-20E2BB63B1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09524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7823A6A-CA98-4F56-945F-789E356276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C3D853-B686-49C3-9472-0C6A3D686B4B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3175183-EE17-4336-AF91-B67CD09941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042BC50-4A0E-4C8D-935A-B5A28E7133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1C481-E529-4F83-B096-20E2BB63B1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05409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6574098-5FD4-4F21-8E77-C7662EEC67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66E2E9A-0449-4575-B61D-E089676B327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2D5B0B2-F8FE-43A7-9F7F-1EA920E4A5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BCB994B-4033-43F5-9EF2-7A5A0E96C9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C3D853-B686-49C3-9472-0C6A3D686B4B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4330BD5-194A-42B2-B45C-01B37C9EF9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DBB7B65-00E4-4F0C-821D-3CE07CFB1B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1C481-E529-4F83-B096-20E2BB63B1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89855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7F0BB6C-6B30-454A-AC37-E080F82884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5114C72-6596-4C1E-9686-99AD5B93E9C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D879B1C-0C98-4C50-865C-04BAC64B34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BBD4053-2ADB-4818-888B-84CC3A0526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C3D853-B686-49C3-9472-0C6A3D686B4B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A34E387-5297-44D5-9D07-588A3B4A85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00DFED1-DECB-4FB1-971C-30BC8017D9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1C481-E529-4F83-B096-20E2BB63B1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4610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81D5D41-1DC3-4E07-A13C-38201A1FA6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24FF106-C24E-46BA-B9FC-D66A12214A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A6ADDAD-FE75-45A1-A499-5C54BC1BC2C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C3D853-B686-49C3-9472-0C6A3D686B4B}" type="datetimeFigureOut">
              <a:rPr lang="zh-CN" altLang="en-US" smtClean="0"/>
              <a:t>2023/1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CC7B3F8-257A-46FE-B6FD-771A87627D0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C055DDF-2B48-408B-9F07-B0F9D802DF5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D1C481-E529-4F83-B096-20E2BB63B1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31332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CA6F7C1F-1C50-4BFF-988B-CC6FAE80EA33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36937" y="349250"/>
            <a:ext cx="5318125" cy="4852670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id="{BEC976A8-3A62-4E6B-8CB0-53C0D1F66C0D}"/>
              </a:ext>
            </a:extLst>
          </p:cNvPr>
          <p:cNvSpPr/>
          <p:nvPr/>
        </p:nvSpPr>
        <p:spPr>
          <a:xfrm>
            <a:off x="1061719" y="5644453"/>
            <a:ext cx="1006856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tabLst>
                <a:tab pos="6192520" algn="r"/>
              </a:tabLst>
            </a:pPr>
            <a:r>
              <a:rPr lang="en-US" altLang="zh-CN" sz="1400" b="1" kern="1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. S6</a:t>
            </a:r>
            <a:r>
              <a:rPr lang="en-US" altLang="zh-CN" sz="1400" kern="1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The original gel image including Figure 7A. This gel image included two separate experimental gel diagrams, and the upper half was Figure 7A. Lane 1-3, 6-7, 13, positive transformants; Lane 4, 9, DNA maker; Lane 5, 8, negative transformants; Lane 10, 11, negative control; Lane 12, invalid amplification. </a:t>
            </a:r>
            <a:endParaRPr lang="zh-CN" altLang="zh-CN" sz="1400" kern="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515532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70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宋体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Lenovo</cp:lastModifiedBy>
  <cp:revision>4</cp:revision>
  <dcterms:created xsi:type="dcterms:W3CDTF">2023-01-05T09:14:48Z</dcterms:created>
  <dcterms:modified xsi:type="dcterms:W3CDTF">2023-01-05T14:22:49Z</dcterms:modified>
</cp:coreProperties>
</file>